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3" r:id="rId8"/>
    <p:sldId id="262" r:id="rId9"/>
    <p:sldId id="265" r:id="rId10"/>
    <p:sldId id="266" r:id="rId11"/>
    <p:sldId id="267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84" autoAdjust="0"/>
    <p:restoredTop sz="94684"/>
  </p:normalViewPr>
  <p:slideViewPr>
    <p:cSldViewPr snapToGrid="0">
      <p:cViewPr varScale="1">
        <p:scale>
          <a:sx n="110" d="100"/>
          <a:sy n="110" d="100"/>
        </p:scale>
        <p:origin x="768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11F00E-54E5-3119-79B7-B7F2E4850A4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8467B38-A1AA-3DE0-E81B-10DD29786BB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B063972-8C73-8A92-B0E7-62C29A7CD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C2EBE7-3879-CE9A-2273-516CDF198F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0E1DD5-7CF5-79CF-9E97-19A7FABA22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39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D6C784-FB84-0E8E-F447-7D21123131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6AD119E-A2D0-3829-1A8E-A75242E055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05CE13-676E-4C16-5AF3-CA4FC7671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3F4C59-F959-C68A-A485-9721A47E5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B242F1-AB5C-F057-397A-A0204CAA1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55498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6C2809C-7279-5B34-F24C-0DB49377C94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9997066-F951-5260-3836-035B909E5E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3E947E-58EB-87B2-8793-C483DAD748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2169F8-334F-3389-6498-26876D1134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DDF93C-7650-B688-91AA-931D2A7221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7232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073E2D9-D333-776B-865D-042E1497EF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8BCF26-40D1-094A-E27E-88B4F9E69C7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414330-7699-8527-7788-5E491D4904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0A5950-7551-F47A-D591-570DF29782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55895E-B0C3-298F-09B9-0511C40CF6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7345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3808FC-F5F1-842C-1678-E45F622592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94E0E2-F544-3DEE-21ED-4464DDE169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8CF7AF-6D19-43CD-F0C3-4BFD1FE9F5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B0D27F6-E10C-8D2D-C3A2-CCCB410184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FFB14D-DE01-60FA-CC75-1DF590B368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12710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013010-219B-E4AB-35B5-79FFAE8F9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F2532DA-405D-CA7B-64DB-3D29747005F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69DE880-C90A-FB26-8DA2-214FAB3220F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A6110F-E55B-3A4F-AE8B-B4354C8F7A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26B6F8-B014-6776-667F-FDE433A908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40AF82-BBD3-FBB0-3EB9-9158EB857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66417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8CBB04-BC0C-2269-592F-92CF1CBC0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64655FD-AE9D-6F01-AE89-4D05FF2343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49DE6B-78B7-FD33-1554-6E5958DEAE8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97B8F1-2C69-33FC-A6AA-201B76A2D2C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9312A6B-EE30-4C14-F37F-00DA4050C0D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68DA09A-280E-335D-9D23-23DE72573D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111DC2-EFE7-B02F-856D-27388E1E37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8DABC6C-7CEF-19CB-F3EB-3C44CBBED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374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4FFC70-35C5-01B2-0E22-A50920DC66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D36B110-6810-B247-E0CD-325D434DFA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C087286-A3F6-1050-A9EA-7232B733D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AD410D-A378-12CC-0294-5FCBC047D6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5403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7F2B70E-9F29-7EE5-26F2-7E16A428D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93FBE0-F005-AC49-E90B-F79BEF72B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7911C8-152D-7FF9-2209-E27D890346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10554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56314-7343-3364-6D90-F1692E7CC2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BB0B78-A58F-5C6A-D30F-B1572F4BDFF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277400E-158A-E2A3-AA8B-2EDEE3ED5E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BA8DBB-78AD-E97E-4778-6B8AEB425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F454AE-6E91-99CA-5B70-6E332E13A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14D214-DF6D-D985-C2FE-A4411B69E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09483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C5242D-B7E7-6E8A-7967-A3C2ADC6A4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113835B-B2D9-2D0A-CC48-32DCEC60238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1846326-8291-8999-5946-4772D3EA04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13AA27-5B2B-135B-57E5-1B37AE4D8E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378361-D3E7-6B20-689E-3F9FAD9A5D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C62DCED-D787-641B-1934-A710AAF68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0862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C0DDD0C-73F0-EE74-76CD-626F81EB0B6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960AFD-9F62-8CFB-0282-56A51EA7FA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CBD91-EDEA-6F92-8B92-E948E8CB7A5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8A1A8E2-943C-4828-8C4A-D7C26B755420}" type="datetimeFigureOut">
              <a:rPr lang="en-US" smtClean="0"/>
              <a:t>12/1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4E7361-B59C-25AC-01A9-EBB0967C86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218D9F-74FB-D0BD-4249-266034E50A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BA3C1A4-E793-4FD1-8876-59F6F118EF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07753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george.shields@furman.edu" TargetMode="Externa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2.jpg"/><Relationship Id="rId2" Type="http://schemas.openxmlformats.org/officeDocument/2006/relationships/image" Target="../media/image6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3.jp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jpg"/><Relationship Id="rId2" Type="http://schemas.openxmlformats.org/officeDocument/2006/relationships/image" Target="../media/image64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6.jp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jpg"/><Relationship Id="rId3" Type="http://schemas.openxmlformats.org/officeDocument/2006/relationships/image" Target="../media/image6.jpg"/><Relationship Id="rId7" Type="http://schemas.openxmlformats.org/officeDocument/2006/relationships/image" Target="../media/image10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jpg"/><Relationship Id="rId11" Type="http://schemas.openxmlformats.org/officeDocument/2006/relationships/image" Target="../media/image14.jpg"/><Relationship Id="rId5" Type="http://schemas.openxmlformats.org/officeDocument/2006/relationships/image" Target="../media/image8.jpg"/><Relationship Id="rId10" Type="http://schemas.openxmlformats.org/officeDocument/2006/relationships/image" Target="../media/image13.jpg"/><Relationship Id="rId4" Type="http://schemas.openxmlformats.org/officeDocument/2006/relationships/image" Target="../media/image7.jpg"/><Relationship Id="rId9" Type="http://schemas.openxmlformats.org/officeDocument/2006/relationships/image" Target="../media/image12.jp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jpg"/><Relationship Id="rId3" Type="http://schemas.openxmlformats.org/officeDocument/2006/relationships/image" Target="../media/image16.jpg"/><Relationship Id="rId7" Type="http://schemas.openxmlformats.org/officeDocument/2006/relationships/image" Target="../media/image20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g"/><Relationship Id="rId11" Type="http://schemas.openxmlformats.org/officeDocument/2006/relationships/image" Target="../media/image24.jpg"/><Relationship Id="rId5" Type="http://schemas.openxmlformats.org/officeDocument/2006/relationships/image" Target="../media/image18.jpg"/><Relationship Id="rId10" Type="http://schemas.openxmlformats.org/officeDocument/2006/relationships/image" Target="../media/image23.jpg"/><Relationship Id="rId4" Type="http://schemas.openxmlformats.org/officeDocument/2006/relationships/image" Target="../media/image17.jpg"/><Relationship Id="rId9" Type="http://schemas.openxmlformats.org/officeDocument/2006/relationships/image" Target="../media/image22.jp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jpg"/><Relationship Id="rId3" Type="http://schemas.openxmlformats.org/officeDocument/2006/relationships/image" Target="../media/image26.jpg"/><Relationship Id="rId7" Type="http://schemas.openxmlformats.org/officeDocument/2006/relationships/image" Target="../media/image30.jpg"/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jpg"/><Relationship Id="rId5" Type="http://schemas.openxmlformats.org/officeDocument/2006/relationships/image" Target="../media/image28.jpg"/><Relationship Id="rId10" Type="http://schemas.openxmlformats.org/officeDocument/2006/relationships/image" Target="../media/image33.jpg"/><Relationship Id="rId4" Type="http://schemas.openxmlformats.org/officeDocument/2006/relationships/image" Target="../media/image27.jpg"/><Relationship Id="rId9" Type="http://schemas.openxmlformats.org/officeDocument/2006/relationships/image" Target="../media/image32.jp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jpg"/><Relationship Id="rId3" Type="http://schemas.openxmlformats.org/officeDocument/2006/relationships/image" Target="../media/image35.jpg"/><Relationship Id="rId7" Type="http://schemas.openxmlformats.org/officeDocument/2006/relationships/image" Target="../media/image39.jpg"/><Relationship Id="rId2" Type="http://schemas.openxmlformats.org/officeDocument/2006/relationships/image" Target="../media/image3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8.jpg"/><Relationship Id="rId11" Type="http://schemas.openxmlformats.org/officeDocument/2006/relationships/image" Target="../media/image43.jpg"/><Relationship Id="rId5" Type="http://schemas.openxmlformats.org/officeDocument/2006/relationships/image" Target="../media/image37.jpg"/><Relationship Id="rId10" Type="http://schemas.openxmlformats.org/officeDocument/2006/relationships/image" Target="../media/image42.jpg"/><Relationship Id="rId4" Type="http://schemas.openxmlformats.org/officeDocument/2006/relationships/image" Target="../media/image36.jpg"/><Relationship Id="rId9" Type="http://schemas.openxmlformats.org/officeDocument/2006/relationships/image" Target="../media/image41.jp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0.jpg"/><Relationship Id="rId13" Type="http://schemas.openxmlformats.org/officeDocument/2006/relationships/image" Target="../media/image55.jpg"/><Relationship Id="rId3" Type="http://schemas.openxmlformats.org/officeDocument/2006/relationships/image" Target="../media/image45.jpg"/><Relationship Id="rId7" Type="http://schemas.openxmlformats.org/officeDocument/2006/relationships/image" Target="../media/image49.jpg"/><Relationship Id="rId12" Type="http://schemas.openxmlformats.org/officeDocument/2006/relationships/image" Target="../media/image54.jpg"/><Relationship Id="rId2" Type="http://schemas.openxmlformats.org/officeDocument/2006/relationships/image" Target="../media/image44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jpg"/><Relationship Id="rId11" Type="http://schemas.openxmlformats.org/officeDocument/2006/relationships/image" Target="../media/image53.jpg"/><Relationship Id="rId5" Type="http://schemas.openxmlformats.org/officeDocument/2006/relationships/image" Target="../media/image47.jpg"/><Relationship Id="rId15" Type="http://schemas.openxmlformats.org/officeDocument/2006/relationships/image" Target="../media/image57.jpg"/><Relationship Id="rId10" Type="http://schemas.openxmlformats.org/officeDocument/2006/relationships/image" Target="../media/image52.jpg"/><Relationship Id="rId4" Type="http://schemas.openxmlformats.org/officeDocument/2006/relationships/image" Target="../media/image46.jpg"/><Relationship Id="rId9" Type="http://schemas.openxmlformats.org/officeDocument/2006/relationships/image" Target="../media/image51.jpg"/><Relationship Id="rId14" Type="http://schemas.openxmlformats.org/officeDocument/2006/relationships/image" Target="../media/image56.jp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jpg"/><Relationship Id="rId2" Type="http://schemas.openxmlformats.org/officeDocument/2006/relationships/image" Target="../media/image58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ubtitle 2">
            <a:extLst>
              <a:ext uri="{FF2B5EF4-FFF2-40B4-BE49-F238E27FC236}">
                <a16:creationId xmlns:a16="http://schemas.microsoft.com/office/drawing/2014/main" id="{AAA1FE82-014A-B4B7-E95E-793A63D2C380}"/>
              </a:ext>
            </a:extLst>
          </p:cNvPr>
          <p:cNvSpPr txBox="1">
            <a:spLocks/>
          </p:cNvSpPr>
          <p:nvPr/>
        </p:nvSpPr>
        <p:spPr>
          <a:xfrm>
            <a:off x="609599" y="591671"/>
            <a:ext cx="10434918" cy="4289612"/>
          </a:xfrm>
          <a:prstGeom prst="rect">
            <a:avLst/>
          </a:prstGeom>
        </p:spPr>
        <p:txBody>
          <a:bodyPr/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b="1" dirty="0"/>
              <a:t>The Hydration of Trifluoroacetic</a:t>
            </a:r>
            <a:r>
              <a:rPr lang="en-US" dirty="0"/>
              <a:t> </a:t>
            </a:r>
            <a:r>
              <a:rPr lang="en-US" b="1" dirty="0"/>
              <a:t> Acid from 0 K to 298 K</a:t>
            </a:r>
            <a:endParaRPr lang="en-US" dirty="0"/>
          </a:p>
          <a:p>
            <a:pPr marL="0" indent="0">
              <a:buNone/>
            </a:pPr>
            <a:r>
              <a:rPr lang="en-US" dirty="0"/>
              <a:t>Walker J. Smith, Caroline S. Glick, George C. Shields*</a:t>
            </a:r>
          </a:p>
          <a:p>
            <a:pPr marL="0" indent="0">
              <a:buNone/>
            </a:pPr>
            <a:r>
              <a:rPr lang="en-US" dirty="0"/>
              <a:t>Furman University, Department of Chemistry, 3300 Poinsett Hwy, Greenville, SC 29613, USA</a:t>
            </a:r>
          </a:p>
          <a:p>
            <a:pPr marL="0" indent="0">
              <a:buNone/>
            </a:pPr>
            <a:r>
              <a:rPr lang="en-US" dirty="0"/>
              <a:t>Email: </a:t>
            </a:r>
            <a:r>
              <a:rPr lang="en-US" u="sng" dirty="0">
                <a:hlinkClick r:id="rId2"/>
              </a:rPr>
              <a:t>george.shields@furman.edu</a:t>
            </a:r>
            <a:r>
              <a:rPr lang="en-US" dirty="0"/>
              <a:t>	</a:t>
            </a:r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endParaRPr lang="en-US" dirty="0"/>
          </a:p>
          <a:p>
            <a:pPr marL="0" indent="0">
              <a:buNone/>
            </a:pPr>
            <a:r>
              <a:rPr lang="en-US" dirty="0"/>
              <a:t>Lowest energy structures according to DLPNO-CCSD(T)/haug-cc-pV6Z//</a:t>
            </a:r>
            <a:r>
              <a:rPr lang="en-US" dirty="0">
                <a:sym typeface="Symbol" pitchFamily="2" charset="2"/>
              </a:rPr>
              <a:t></a:t>
            </a:r>
            <a:r>
              <a:rPr lang="en-US" dirty="0"/>
              <a:t>B97X-D/6-31++G** for n=1-4 and to DLPNO-CCSD(T)/haug-cc-pV5Z//</a:t>
            </a:r>
            <a:r>
              <a:rPr lang="en-US" dirty="0">
                <a:sym typeface="Symbol" pitchFamily="2" charset="2"/>
              </a:rPr>
              <a:t></a:t>
            </a:r>
            <a:r>
              <a:rPr lang="en-US" dirty="0"/>
              <a:t>B97X-D/6-31++G**.</a:t>
            </a:r>
          </a:p>
        </p:txBody>
      </p:sp>
    </p:spTree>
    <p:extLst>
      <p:ext uri="{BB962C8B-B14F-4D97-AF65-F5344CB8AC3E}">
        <p14:creationId xmlns:p14="http://schemas.microsoft.com/office/powerpoint/2010/main" val="103336943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AFD7FE2E-6A51-3F42-4968-5827D620BE73}"/>
              </a:ext>
            </a:extLst>
          </p:cNvPr>
          <p:cNvSpPr txBox="1"/>
          <p:nvPr/>
        </p:nvSpPr>
        <p:spPr>
          <a:xfrm>
            <a:off x="5376668" y="118872"/>
            <a:ext cx="14300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. TFA-7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pic>
        <p:nvPicPr>
          <p:cNvPr id="4" name="Picture 3" descr="Several red and white objects&#10;&#10;AI-generated content may be incorrect.">
            <a:extLst>
              <a:ext uri="{FF2B5EF4-FFF2-40B4-BE49-F238E27FC236}">
                <a16:creationId xmlns:a16="http://schemas.microsoft.com/office/drawing/2014/main" id="{D1745B34-F4DE-0EAA-9BF8-C4DE8957678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422381"/>
            <a:ext cx="4050793" cy="29852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ECC47607-4335-03BA-4CF8-2E6059A8D5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50792" y="1422381"/>
            <a:ext cx="4219004" cy="29852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Several red and white pills&#10;&#10;AI-generated content may be incorrect.">
            <a:extLst>
              <a:ext uri="{FF2B5EF4-FFF2-40B4-BE49-F238E27FC236}">
                <a16:creationId xmlns:a16="http://schemas.microsoft.com/office/drawing/2014/main" id="{3262814C-C0C7-A9CD-8A39-28210F38146F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9796" y="1422381"/>
            <a:ext cx="3922204" cy="298523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473BDE4-CE47-949C-9F14-964ED2A71C31}"/>
              </a:ext>
            </a:extLst>
          </p:cNvPr>
          <p:cNvSpPr txBox="1"/>
          <p:nvPr/>
        </p:nvSpPr>
        <p:spPr>
          <a:xfrm>
            <a:off x="181198" y="4907277"/>
            <a:ext cx="36204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0 kcal/mol (43.95%)</a:t>
            </a:r>
          </a:p>
          <a:p>
            <a:r>
              <a:rPr lang="el-GR" dirty="0"/>
              <a:t>Δ</a:t>
            </a:r>
            <a:r>
              <a:rPr lang="en-US" dirty="0"/>
              <a:t>G(273.15K) = 0 kcal/mol (21.94%)</a:t>
            </a:r>
          </a:p>
          <a:p>
            <a:r>
              <a:rPr lang="el-GR" dirty="0"/>
              <a:t>Δ</a:t>
            </a:r>
            <a:r>
              <a:rPr lang="en-US" dirty="0"/>
              <a:t>G(298.15K) = 0 kcal/mol (15.41%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6A40DD1-987E-3F93-7933-E27334B161C7}"/>
              </a:ext>
            </a:extLst>
          </p:cNvPr>
          <p:cNvSpPr txBox="1"/>
          <p:nvPr/>
        </p:nvSpPr>
        <p:spPr>
          <a:xfrm>
            <a:off x="4190092" y="4907277"/>
            <a:ext cx="393300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1.11 kcal/mol (3.37%)</a:t>
            </a:r>
          </a:p>
          <a:p>
            <a:r>
              <a:rPr lang="el-GR" dirty="0"/>
              <a:t>Δ</a:t>
            </a:r>
            <a:r>
              <a:rPr lang="en-US" dirty="0"/>
              <a:t>G(273.15K) = .46 kcal/mol (9.37%)</a:t>
            </a:r>
          </a:p>
          <a:p>
            <a:r>
              <a:rPr lang="el-GR" dirty="0"/>
              <a:t>Δ</a:t>
            </a:r>
            <a:r>
              <a:rPr lang="en-US" dirty="0"/>
              <a:t>G(298.15K) = .17 kcal/mol (11.59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94B6F3-E12C-5458-DE3D-8A00816DCB08}"/>
              </a:ext>
            </a:extLst>
          </p:cNvPr>
          <p:cNvSpPr txBox="1"/>
          <p:nvPr/>
        </p:nvSpPr>
        <p:spPr>
          <a:xfrm>
            <a:off x="8269796" y="4907277"/>
            <a:ext cx="380956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.21 kcal/mol (27.23%)</a:t>
            </a:r>
          </a:p>
          <a:p>
            <a:r>
              <a:rPr lang="el-GR" dirty="0"/>
              <a:t>Δ</a:t>
            </a:r>
            <a:r>
              <a:rPr lang="en-US" dirty="0"/>
              <a:t>G(273.15K) = .20 kcal/mol (15.23%)</a:t>
            </a:r>
          </a:p>
          <a:p>
            <a:r>
              <a:rPr lang="el-GR" dirty="0"/>
              <a:t>Δ</a:t>
            </a:r>
            <a:r>
              <a:rPr lang="en-US" dirty="0"/>
              <a:t>G(298.15K) = .20 kcal/mol (11.09%)</a:t>
            </a:r>
          </a:p>
        </p:txBody>
      </p:sp>
    </p:spTree>
    <p:extLst>
      <p:ext uri="{BB962C8B-B14F-4D97-AF65-F5344CB8AC3E}">
        <p14:creationId xmlns:p14="http://schemas.microsoft.com/office/powerpoint/2010/main" val="185252713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72D80B8B-31C0-15E3-08AD-1E3AE414321C}"/>
              </a:ext>
            </a:extLst>
          </p:cNvPr>
          <p:cNvSpPr txBox="1"/>
          <p:nvPr/>
        </p:nvSpPr>
        <p:spPr>
          <a:xfrm>
            <a:off x="5376668" y="118872"/>
            <a:ext cx="1438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8. TFA-8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pic>
        <p:nvPicPr>
          <p:cNvPr id="4" name="Picture 3" descr="A close-up of several pills&#10;&#10;AI-generated content may be incorrect.">
            <a:extLst>
              <a:ext uri="{FF2B5EF4-FFF2-40B4-BE49-F238E27FC236}">
                <a16:creationId xmlns:a16="http://schemas.microsoft.com/office/drawing/2014/main" id="{FBED579C-F2D6-974D-D4FE-F8B2C8A901C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153552"/>
            <a:ext cx="3923876" cy="29978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Several pills floating in the air&#10;&#10;AI-generated content may be incorrect.">
            <a:extLst>
              <a:ext uri="{FF2B5EF4-FFF2-40B4-BE49-F238E27FC236}">
                <a16:creationId xmlns:a16="http://schemas.microsoft.com/office/drawing/2014/main" id="{21255760-CB83-54F5-4B8B-8A28543E656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3876" y="1153553"/>
            <a:ext cx="4134062" cy="29978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Several red and white pills&#10;&#10;AI-generated content may be incorrect.">
            <a:extLst>
              <a:ext uri="{FF2B5EF4-FFF2-40B4-BE49-F238E27FC236}">
                <a16:creationId xmlns:a16="http://schemas.microsoft.com/office/drawing/2014/main" id="{91C5369A-1F99-4DDA-94D7-46731F1095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57938" y="1153552"/>
            <a:ext cx="4134062" cy="299782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63F9395-9271-907C-87E2-6F0FB1BC0E98}"/>
              </a:ext>
            </a:extLst>
          </p:cNvPr>
          <p:cNvSpPr txBox="1"/>
          <p:nvPr/>
        </p:nvSpPr>
        <p:spPr>
          <a:xfrm>
            <a:off x="181198" y="4907277"/>
            <a:ext cx="36204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0 kcal/mol (23.73%)</a:t>
            </a:r>
          </a:p>
          <a:p>
            <a:r>
              <a:rPr lang="el-GR" dirty="0"/>
              <a:t>Δ</a:t>
            </a:r>
            <a:r>
              <a:rPr lang="en-US" dirty="0"/>
              <a:t>G(273.15K) = 0 kcal/mol (14.11%)</a:t>
            </a:r>
          </a:p>
          <a:p>
            <a:r>
              <a:rPr lang="el-GR" dirty="0"/>
              <a:t>Δ</a:t>
            </a:r>
            <a:r>
              <a:rPr lang="en-US" dirty="0"/>
              <a:t>G(298.15K) = 0 kcal/mol (11.32%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8A1A99E-7AEB-2668-D167-8AE5191AE5B4}"/>
              </a:ext>
            </a:extLst>
          </p:cNvPr>
          <p:cNvSpPr txBox="1"/>
          <p:nvPr/>
        </p:nvSpPr>
        <p:spPr>
          <a:xfrm>
            <a:off x="4089328" y="4907277"/>
            <a:ext cx="380956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.52 kcal/mol (7.17%)</a:t>
            </a:r>
          </a:p>
          <a:p>
            <a:r>
              <a:rPr lang="el-GR" dirty="0"/>
              <a:t>Δ</a:t>
            </a:r>
            <a:r>
              <a:rPr lang="en-US" dirty="0"/>
              <a:t>G(273.15K) = .54 kcal/mol (5.24%)</a:t>
            </a:r>
          </a:p>
          <a:p>
            <a:r>
              <a:rPr lang="el-GR" dirty="0"/>
              <a:t>Δ</a:t>
            </a:r>
            <a:r>
              <a:rPr lang="en-US" dirty="0"/>
              <a:t>G(298.15K) = .55 kcal/mol (4.51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FA469F-DF32-6714-4D47-0D63DB0A5474}"/>
              </a:ext>
            </a:extLst>
          </p:cNvPr>
          <p:cNvSpPr txBox="1"/>
          <p:nvPr/>
        </p:nvSpPr>
        <p:spPr>
          <a:xfrm>
            <a:off x="8223390" y="4907277"/>
            <a:ext cx="380956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.65 kcal/mol (5.20%)</a:t>
            </a:r>
          </a:p>
          <a:p>
            <a:r>
              <a:rPr lang="el-GR" dirty="0"/>
              <a:t>Δ</a:t>
            </a:r>
            <a:r>
              <a:rPr lang="en-US" dirty="0"/>
              <a:t>G(273.15K) = .58 kcal/mol (4.83%)</a:t>
            </a:r>
          </a:p>
          <a:p>
            <a:r>
              <a:rPr lang="el-GR" dirty="0"/>
              <a:t>Δ</a:t>
            </a:r>
            <a:r>
              <a:rPr lang="en-US" dirty="0"/>
              <a:t>G(298.15K) = .55 kcal/mol (4.49%)</a:t>
            </a:r>
          </a:p>
        </p:txBody>
      </p:sp>
    </p:spTree>
    <p:extLst>
      <p:ext uri="{BB962C8B-B14F-4D97-AF65-F5344CB8AC3E}">
        <p14:creationId xmlns:p14="http://schemas.microsoft.com/office/powerpoint/2010/main" val="160752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several molecular structures&#10;&#10;AI-generated content may be incorrect.">
            <a:extLst>
              <a:ext uri="{FF2B5EF4-FFF2-40B4-BE49-F238E27FC236}">
                <a16:creationId xmlns:a16="http://schemas.microsoft.com/office/drawing/2014/main" id="{7669EC0A-FBEE-8170-3EFC-88430BF2B08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60992" y="736147"/>
            <a:ext cx="4270016" cy="3194876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7BB0B9EB-EC0A-9123-A081-30749C6FAF2F}"/>
              </a:ext>
            </a:extLst>
          </p:cNvPr>
          <p:cNvSpPr txBox="1"/>
          <p:nvPr/>
        </p:nvSpPr>
        <p:spPr>
          <a:xfrm>
            <a:off x="4204039" y="4735695"/>
            <a:ext cx="3783921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. TFA-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  <a:p>
            <a:r>
              <a:rPr lang="el-GR" dirty="0"/>
              <a:t>Δ</a:t>
            </a:r>
            <a:r>
              <a:rPr lang="en-US" dirty="0"/>
              <a:t>G(216.65K) = 0.00 kcal/mol (100%)</a:t>
            </a:r>
          </a:p>
          <a:p>
            <a:r>
              <a:rPr lang="el-GR" dirty="0"/>
              <a:t>Δ</a:t>
            </a:r>
            <a:r>
              <a:rPr lang="en-US" dirty="0"/>
              <a:t>G(273.15K) = 0.00 kcal/mol (100%)</a:t>
            </a:r>
          </a:p>
          <a:p>
            <a:r>
              <a:rPr lang="el-GR" dirty="0"/>
              <a:t>Δ</a:t>
            </a:r>
            <a:r>
              <a:rPr lang="en-US" dirty="0"/>
              <a:t>G(298.15K) = 0.00 kcal/mol (100%) </a:t>
            </a:r>
          </a:p>
        </p:txBody>
      </p:sp>
    </p:spTree>
    <p:extLst>
      <p:ext uri="{BB962C8B-B14F-4D97-AF65-F5344CB8AC3E}">
        <p14:creationId xmlns:p14="http://schemas.microsoft.com/office/powerpoint/2010/main" val="336878854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close-up of several pills&#10;&#10;AI-generated content may be incorrect.">
            <a:extLst>
              <a:ext uri="{FF2B5EF4-FFF2-40B4-BE49-F238E27FC236}">
                <a16:creationId xmlns:a16="http://schemas.microsoft.com/office/drawing/2014/main" id="{05DB1405-BA4F-E195-9508-FAF83A16629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16476" y="938210"/>
            <a:ext cx="4165554" cy="31548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E8A1154B-76D9-977B-66C8-9ADFF45B929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938210"/>
            <a:ext cx="4191015" cy="315481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A close-up of several molecular structures&#10;&#10;AI-generated content may be incorrect.">
            <a:extLst>
              <a:ext uri="{FF2B5EF4-FFF2-40B4-BE49-F238E27FC236}">
                <a16:creationId xmlns:a16="http://schemas.microsoft.com/office/drawing/2014/main" id="{F38FF42E-5D4E-8BA5-1640-37CB535AF6A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30" y="938210"/>
            <a:ext cx="3809974" cy="315481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0A6E71D6-CFE8-1F21-0A25-54613DCF3CFF}"/>
              </a:ext>
            </a:extLst>
          </p:cNvPr>
          <p:cNvSpPr txBox="1"/>
          <p:nvPr/>
        </p:nvSpPr>
        <p:spPr>
          <a:xfrm>
            <a:off x="4372212" y="4907277"/>
            <a:ext cx="380315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0 kcal/mol (50.87%)</a:t>
            </a:r>
          </a:p>
          <a:p>
            <a:r>
              <a:rPr lang="el-GR" dirty="0"/>
              <a:t>Δ</a:t>
            </a:r>
            <a:r>
              <a:rPr lang="en-US" dirty="0"/>
              <a:t>G(273.15K) = .06 kcal/mol (46.45%)</a:t>
            </a:r>
          </a:p>
          <a:p>
            <a:r>
              <a:rPr lang="el-GR" dirty="0"/>
              <a:t>Δ</a:t>
            </a:r>
            <a:r>
              <a:rPr lang="en-US" dirty="0"/>
              <a:t>G(298.15K) = .09 kcal/mol (44.52%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0B783FB-2233-00A1-8F79-80905945CAD8}"/>
              </a:ext>
            </a:extLst>
          </p:cNvPr>
          <p:cNvSpPr txBox="1"/>
          <p:nvPr/>
        </p:nvSpPr>
        <p:spPr>
          <a:xfrm>
            <a:off x="181198" y="4907277"/>
            <a:ext cx="380315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.02 kcal/mol (48.86%)</a:t>
            </a:r>
          </a:p>
          <a:p>
            <a:r>
              <a:rPr lang="el-GR" dirty="0"/>
              <a:t>Δ</a:t>
            </a:r>
            <a:r>
              <a:rPr lang="en-US" dirty="0"/>
              <a:t>G(273.15K) = 0 kcal/mol (51.75%)</a:t>
            </a:r>
          </a:p>
          <a:p>
            <a:r>
              <a:rPr lang="el-GR" dirty="0"/>
              <a:t>Δ</a:t>
            </a:r>
            <a:r>
              <a:rPr lang="en-US" dirty="0"/>
              <a:t>G(298.15K) = 0 kcal/mol (52.15%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C80B16D-0837-F6D5-7597-A6220A0B2D5F}"/>
              </a:ext>
            </a:extLst>
          </p:cNvPr>
          <p:cNvSpPr txBox="1"/>
          <p:nvPr/>
        </p:nvSpPr>
        <p:spPr>
          <a:xfrm>
            <a:off x="8382030" y="4907277"/>
            <a:ext cx="3803157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2.29 kcal/mol (0.25%)</a:t>
            </a:r>
          </a:p>
          <a:p>
            <a:r>
              <a:rPr lang="el-GR" dirty="0"/>
              <a:t>Δ</a:t>
            </a:r>
            <a:r>
              <a:rPr lang="en-US" dirty="0"/>
              <a:t>G(273.15K) = 1.87 kcal/mol (1.66%)</a:t>
            </a:r>
          </a:p>
          <a:p>
            <a:r>
              <a:rPr lang="el-GR" dirty="0"/>
              <a:t>Δ</a:t>
            </a:r>
            <a:r>
              <a:rPr lang="en-US" dirty="0"/>
              <a:t>G(298.15K) = 1.68 kcal/mol (3.05%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32521D7-6A6A-26CB-A6B3-BE780B2086F5}"/>
              </a:ext>
            </a:extLst>
          </p:cNvPr>
          <p:cNvSpPr txBox="1"/>
          <p:nvPr/>
        </p:nvSpPr>
        <p:spPr>
          <a:xfrm>
            <a:off x="5554459" y="274320"/>
            <a:ext cx="1438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2. TFA-2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</p:spTree>
    <p:extLst>
      <p:ext uri="{BB962C8B-B14F-4D97-AF65-F5344CB8AC3E}">
        <p14:creationId xmlns:p14="http://schemas.microsoft.com/office/powerpoint/2010/main" val="25681545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Several pills on a white background">
            <a:extLst>
              <a:ext uri="{FF2B5EF4-FFF2-40B4-BE49-F238E27FC236}">
                <a16:creationId xmlns:a16="http://schemas.microsoft.com/office/drawing/2014/main" id="{B350A2F5-2655-F601-39D5-E24514DB84B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74886"/>
            <a:ext cx="2542950" cy="18192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Picture 4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726019DC-0AC7-686B-8272-43631F6690D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4487" y="479885"/>
            <a:ext cx="2347391" cy="18192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3FE29F20-15D4-EEC0-D993-A3F665F28BA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17461" y="479885"/>
            <a:ext cx="2512365" cy="180799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B17730C5-E2DB-DC25-9BD1-380F36054A6D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9826" y="479885"/>
            <a:ext cx="2481798" cy="18192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Several molecular structures of a substance&#10;&#10;AI-generated content may be incorrect.">
            <a:extLst>
              <a:ext uri="{FF2B5EF4-FFF2-40B4-BE49-F238E27FC236}">
                <a16:creationId xmlns:a16="http://schemas.microsoft.com/office/drawing/2014/main" id="{799B7F79-5832-741A-ADE7-32869BE2D58E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11624" y="479884"/>
            <a:ext cx="2268895" cy="18192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5AEBA16-0541-5518-536F-9C124B505D49}"/>
              </a:ext>
            </a:extLst>
          </p:cNvPr>
          <p:cNvSpPr txBox="1"/>
          <p:nvPr/>
        </p:nvSpPr>
        <p:spPr>
          <a:xfrm>
            <a:off x="5376668" y="99268"/>
            <a:ext cx="1438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. TFA-3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pic>
        <p:nvPicPr>
          <p:cNvPr id="14" name="Picture 13" descr="Several pills on a white background&#10;&#10;AI-generated content may be incorrect.">
            <a:extLst>
              <a:ext uri="{FF2B5EF4-FFF2-40B4-BE49-F238E27FC236}">
                <a16:creationId xmlns:a16="http://schemas.microsoft.com/office/drawing/2014/main" id="{7C3EC0F5-C796-D9C5-046C-C7D0D8365D2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01954"/>
            <a:ext cx="2622336" cy="18225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 descr="Several pills floating in the air&#10;&#10;AI-generated content may be incorrect.">
            <a:extLst>
              <a:ext uri="{FF2B5EF4-FFF2-40B4-BE49-F238E27FC236}">
                <a16:creationId xmlns:a16="http://schemas.microsoft.com/office/drawing/2014/main" id="{D1871541-8940-6968-FCAC-B9583D2B007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28272" y="3601955"/>
            <a:ext cx="2477102" cy="182136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993D1B1D-31AB-0BB7-E4EE-D402776011D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7028" y="3601955"/>
            <a:ext cx="2313432" cy="18234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Several white and red pills&#10;&#10;AI-generated content may be incorrect.">
            <a:extLst>
              <a:ext uri="{FF2B5EF4-FFF2-40B4-BE49-F238E27FC236}">
                <a16:creationId xmlns:a16="http://schemas.microsoft.com/office/drawing/2014/main" id="{8CAC1E2A-3FBE-5B88-42AA-504E469775BF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90460" y="3601956"/>
            <a:ext cx="2326411" cy="18234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Several objects with different colors&#10;&#10;AI-generated content may be incorrect.">
            <a:extLst>
              <a:ext uri="{FF2B5EF4-FFF2-40B4-BE49-F238E27FC236}">
                <a16:creationId xmlns:a16="http://schemas.microsoft.com/office/drawing/2014/main" id="{5E6113FF-AA35-4E7B-4D90-345AD7455C14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2336" y="3604044"/>
            <a:ext cx="2435924" cy="18192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80BCAB6-8ACB-6106-0A2F-993F8255AF03}"/>
              </a:ext>
            </a:extLst>
          </p:cNvPr>
          <p:cNvSpPr txBox="1"/>
          <p:nvPr/>
        </p:nvSpPr>
        <p:spPr>
          <a:xfrm>
            <a:off x="5264904" y="2344751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52 kcal/mol (12.85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55 kcal/mol (13.37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56 kcal/mol (13.05%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F75F98A7-8EA3-A1CC-7125-28E3DE06C714}"/>
              </a:ext>
            </a:extLst>
          </p:cNvPr>
          <p:cNvSpPr txBox="1"/>
          <p:nvPr/>
        </p:nvSpPr>
        <p:spPr>
          <a:xfrm>
            <a:off x="2931559" y="235143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12 kcal/mol (33.21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19 kcal/mol (26.2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23 kcal/mol (23.38%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DA6F2E9-30A3-D10F-A003-2A2201894D6E}"/>
              </a:ext>
            </a:extLst>
          </p:cNvPr>
          <p:cNvSpPr txBox="1"/>
          <p:nvPr/>
        </p:nvSpPr>
        <p:spPr>
          <a:xfrm>
            <a:off x="353058" y="2344751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 kcal/mol (43.65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 kcal/mol (37.40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 kcal/mol (34.28%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E155E11-C650-DA0F-D29C-4782A39BC14F}"/>
              </a:ext>
            </a:extLst>
          </p:cNvPr>
          <p:cNvSpPr txBox="1"/>
          <p:nvPr/>
        </p:nvSpPr>
        <p:spPr>
          <a:xfrm>
            <a:off x="7761986" y="2350393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21 kcal/mol (2.54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01 kcal/mol (5.77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91 kcal/mol (7.25%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F8D504C3-3231-05D9-95AF-AE45B2B95D29}"/>
              </a:ext>
            </a:extLst>
          </p:cNvPr>
          <p:cNvSpPr txBox="1"/>
          <p:nvPr/>
        </p:nvSpPr>
        <p:spPr>
          <a:xfrm>
            <a:off x="10137332" y="2350393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26 kcal/mol (2.30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1 kcal/mol (4.8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03 kcal/mol (5.97%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4180649-EDFA-829F-F8D4-8FE9640FEDEB}"/>
              </a:ext>
            </a:extLst>
          </p:cNvPr>
          <p:cNvSpPr txBox="1"/>
          <p:nvPr/>
        </p:nvSpPr>
        <p:spPr>
          <a:xfrm>
            <a:off x="402429" y="5557410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61 kcal/mol (1.01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45 kcal/mol (2.5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38 kcal/mol (3.27%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185DB5C6-310E-1421-3B7A-AA033DE818E1}"/>
              </a:ext>
            </a:extLst>
          </p:cNvPr>
          <p:cNvSpPr txBox="1"/>
          <p:nvPr/>
        </p:nvSpPr>
        <p:spPr>
          <a:xfrm>
            <a:off x="10068306" y="5574822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62 kcal/mol (0.96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84 kcal/mol (1.21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94 kcal/mol (1.25%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4E283D06-A68C-B388-869E-0275D522565C}"/>
              </a:ext>
            </a:extLst>
          </p:cNvPr>
          <p:cNvSpPr txBox="1"/>
          <p:nvPr/>
        </p:nvSpPr>
        <p:spPr>
          <a:xfrm>
            <a:off x="5187261" y="5558281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91 kcal/mol (0.50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74 kcal/mol (1.4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66 kcal/mol (2.03%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8AFDA2A-1962-E342-5DE3-D39D49E536CC}"/>
              </a:ext>
            </a:extLst>
          </p:cNvPr>
          <p:cNvSpPr txBox="1"/>
          <p:nvPr/>
        </p:nvSpPr>
        <p:spPr>
          <a:xfrm>
            <a:off x="7644926" y="5581502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2.01 kcal/mol (0.36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83 kcal/mol (1.28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72 kcal/mol (1.86%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FDDE005-7517-5AD0-4819-575169639589}"/>
              </a:ext>
            </a:extLst>
          </p:cNvPr>
          <p:cNvSpPr txBox="1"/>
          <p:nvPr/>
        </p:nvSpPr>
        <p:spPr>
          <a:xfrm>
            <a:off x="2972309" y="5558281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75 kcal/mol (0.73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55 kcal/mol (2.11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46 kcal/mol (2.86%)</a:t>
            </a:r>
          </a:p>
        </p:txBody>
      </p:sp>
    </p:spTree>
    <p:extLst>
      <p:ext uri="{BB962C8B-B14F-4D97-AF65-F5344CB8AC3E}">
        <p14:creationId xmlns:p14="http://schemas.microsoft.com/office/powerpoint/2010/main" val="222848380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4AFB4A40-E35A-3004-0BB2-E61C88B780D1}"/>
              </a:ext>
            </a:extLst>
          </p:cNvPr>
          <p:cNvSpPr txBox="1"/>
          <p:nvPr/>
        </p:nvSpPr>
        <p:spPr>
          <a:xfrm>
            <a:off x="5316556" y="100584"/>
            <a:ext cx="17704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. TFA–4H</a:t>
            </a:r>
            <a:r>
              <a:rPr lang="en-US" baseline="-25000" dirty="0"/>
              <a:t>2</a:t>
            </a:r>
            <a:r>
              <a:rPr lang="en-US" dirty="0"/>
              <a:t>O (1)</a:t>
            </a:r>
          </a:p>
        </p:txBody>
      </p:sp>
      <p:pic>
        <p:nvPicPr>
          <p:cNvPr id="4" name="Picture 3" descr="Several white and red pills&#10;&#10;AI-generated content may be incorrect.">
            <a:extLst>
              <a:ext uri="{FF2B5EF4-FFF2-40B4-BE49-F238E27FC236}">
                <a16:creationId xmlns:a16="http://schemas.microsoft.com/office/drawing/2014/main" id="{C8DC5274-FF05-4E50-CB79-237B6E5EC6E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00616" y="3696261"/>
            <a:ext cx="2691384" cy="16009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Several objects with different colors&#10;&#10;AI-generated content may be incorrect.">
            <a:extLst>
              <a:ext uri="{FF2B5EF4-FFF2-40B4-BE49-F238E27FC236}">
                <a16:creationId xmlns:a16="http://schemas.microsoft.com/office/drawing/2014/main" id="{F564722E-F90D-0DFA-6365-FDEC7D2F90F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41406" y="3697723"/>
            <a:ext cx="2559210" cy="1599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Several objects of a molecule&#10;&#10;AI-generated content may be incorrect.">
            <a:extLst>
              <a:ext uri="{FF2B5EF4-FFF2-40B4-BE49-F238E27FC236}">
                <a16:creationId xmlns:a16="http://schemas.microsoft.com/office/drawing/2014/main" id="{B0AE7348-48C8-8F19-5973-C85BF5E8E76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14726" y="3696262"/>
            <a:ext cx="2326680" cy="1600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 descr="Several red and white objects&#10;&#10;AI-generated content may be incorrect.">
            <a:extLst>
              <a:ext uri="{FF2B5EF4-FFF2-40B4-BE49-F238E27FC236}">
                <a16:creationId xmlns:a16="http://schemas.microsoft.com/office/drawing/2014/main" id="{090D4D95-8DA0-4965-D161-68818749DD03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9572" y="3696262"/>
            <a:ext cx="2415153" cy="1600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Several pills on a white background&#10;&#10;AI-generated content may be incorrect.">
            <a:extLst>
              <a:ext uri="{FF2B5EF4-FFF2-40B4-BE49-F238E27FC236}">
                <a16:creationId xmlns:a16="http://schemas.microsoft.com/office/drawing/2014/main" id="{10396434-ABA2-99DC-D5B2-4F32AF27D70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96261"/>
            <a:ext cx="2199571" cy="16009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 descr="Several pills floating in the air&#10;&#10;AI-generated content may be incorrect.">
            <a:extLst>
              <a:ext uri="{FF2B5EF4-FFF2-40B4-BE49-F238E27FC236}">
                <a16:creationId xmlns:a16="http://schemas.microsoft.com/office/drawing/2014/main" id="{E9065F85-E496-1AB6-E4F1-92A47C02DB48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623597" y="527221"/>
            <a:ext cx="2568403" cy="18070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101542EF-E2CB-2CFF-6AA5-896607793ED0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0809" y="528683"/>
            <a:ext cx="2415155" cy="18070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Several white and red pills&#10;&#10;AI-generated content may be incorrect.">
            <a:extLst>
              <a:ext uri="{FF2B5EF4-FFF2-40B4-BE49-F238E27FC236}">
                <a16:creationId xmlns:a16="http://schemas.microsoft.com/office/drawing/2014/main" id="{60B1534D-2111-ED19-6E87-139C5749714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95654" y="527221"/>
            <a:ext cx="2415155" cy="18070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Several white and red pills&#10;&#10;AI-generated content may be incorrect.">
            <a:extLst>
              <a:ext uri="{FF2B5EF4-FFF2-40B4-BE49-F238E27FC236}">
                <a16:creationId xmlns:a16="http://schemas.microsoft.com/office/drawing/2014/main" id="{F154F789-1CE7-96E9-5183-EB663440D81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3484" y="527221"/>
            <a:ext cx="2444537" cy="180704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A close-up of several pills&#10;&#10;AI-generated content may be incorrect.">
            <a:extLst>
              <a:ext uri="{FF2B5EF4-FFF2-40B4-BE49-F238E27FC236}">
                <a16:creationId xmlns:a16="http://schemas.microsoft.com/office/drawing/2014/main" id="{BE14A492-E7A5-FE8C-EF27-B5AD86095F89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7221"/>
            <a:ext cx="2353484" cy="180704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2ADDA6F-4A67-B6F8-2894-863B44C998E3}"/>
              </a:ext>
            </a:extLst>
          </p:cNvPr>
          <p:cNvSpPr txBox="1"/>
          <p:nvPr/>
        </p:nvSpPr>
        <p:spPr>
          <a:xfrm>
            <a:off x="268003" y="2415099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37 kcal/mol (4.67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08 kcal/mol (9.7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 kcal/mol (11.77%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34813D3-CC64-4A00-3BAB-DC59A9D035E5}"/>
              </a:ext>
            </a:extLst>
          </p:cNvPr>
          <p:cNvSpPr txBox="1"/>
          <p:nvPr/>
        </p:nvSpPr>
        <p:spPr>
          <a:xfrm>
            <a:off x="2667013" y="241509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 kcal/mol (10.98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 kcal/mol (11.35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04 kcal/mol (10.95%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A147D549-31C7-DEC0-6550-CBD02F9099BC}"/>
              </a:ext>
            </a:extLst>
          </p:cNvPr>
          <p:cNvSpPr txBox="1"/>
          <p:nvPr/>
        </p:nvSpPr>
        <p:spPr>
          <a:xfrm>
            <a:off x="5187261" y="241509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09 kcal/mol (8.84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18 kcal/mol (8.1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26 kcal/mol (7.63%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9A015880-E32E-20F7-088A-F48226CBFE06}"/>
              </a:ext>
            </a:extLst>
          </p:cNvPr>
          <p:cNvSpPr txBox="1"/>
          <p:nvPr/>
        </p:nvSpPr>
        <p:spPr>
          <a:xfrm>
            <a:off x="7509647" y="241509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02 kcal/mol (10.46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17 kcal/mol (8.35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28 kcal/mol (7.39%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A87544D-2676-699F-3BE5-6AE1BE32ABF3}"/>
              </a:ext>
            </a:extLst>
          </p:cNvPr>
          <p:cNvSpPr txBox="1"/>
          <p:nvPr/>
        </p:nvSpPr>
        <p:spPr>
          <a:xfrm>
            <a:off x="9999059" y="2415097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36 kcal/mol (4.72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42 kcal/mol (5.1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49 kcal/mol (5.11%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615D8A0-C1CD-8613-74CF-0968056E051F}"/>
              </a:ext>
            </a:extLst>
          </p:cNvPr>
          <p:cNvSpPr txBox="1"/>
          <p:nvPr/>
        </p:nvSpPr>
        <p:spPr>
          <a:xfrm>
            <a:off x="191046" y="5378015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28 kcal/mol (5.73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41 kcal/mol (5.33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51 kcal/mol (4.97%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C0A6B145-5AF4-C56A-2529-19AF2222734F}"/>
              </a:ext>
            </a:extLst>
          </p:cNvPr>
          <p:cNvSpPr txBox="1"/>
          <p:nvPr/>
        </p:nvSpPr>
        <p:spPr>
          <a:xfrm>
            <a:off x="2498409" y="537801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84 kcal/mol (1.57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63 kcal/mol (3.54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58 kcal/mol (4.40%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A6371E9-BFA9-ADAE-430D-885DAB944F68}"/>
              </a:ext>
            </a:extLst>
          </p:cNvPr>
          <p:cNvSpPr txBox="1"/>
          <p:nvPr/>
        </p:nvSpPr>
        <p:spPr>
          <a:xfrm>
            <a:off x="4869327" y="537801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49 kcal/mol (3.49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64 kcal/mol (3.4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75 kcal/mol (3.32%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F31028B-F8CF-CA46-90DB-7C4C4F60FF14}"/>
              </a:ext>
            </a:extLst>
          </p:cNvPr>
          <p:cNvSpPr txBox="1"/>
          <p:nvPr/>
        </p:nvSpPr>
        <p:spPr>
          <a:xfrm>
            <a:off x="7312272" y="537801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13 kcal/mol (8.20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53 kcal/mol (4.24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76 kcal/mol (3.24%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DE84993-2B78-1B1B-0D8E-6C6C1C3DAA0E}"/>
              </a:ext>
            </a:extLst>
          </p:cNvPr>
          <p:cNvSpPr txBox="1"/>
          <p:nvPr/>
        </p:nvSpPr>
        <p:spPr>
          <a:xfrm>
            <a:off x="9937569" y="537801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10 kcal/mol (0.85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90 kcal/mol (2.18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84 kcal/mol (2.83%)</a:t>
            </a:r>
          </a:p>
        </p:txBody>
      </p:sp>
    </p:spTree>
    <p:extLst>
      <p:ext uri="{BB962C8B-B14F-4D97-AF65-F5344CB8AC3E}">
        <p14:creationId xmlns:p14="http://schemas.microsoft.com/office/powerpoint/2010/main" val="40400927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F7765B6-4FDA-6AFB-265D-CFF4655D75E9}"/>
              </a:ext>
            </a:extLst>
          </p:cNvPr>
          <p:cNvSpPr txBox="1"/>
          <p:nvPr/>
        </p:nvSpPr>
        <p:spPr>
          <a:xfrm>
            <a:off x="5159883" y="135374"/>
            <a:ext cx="1872234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/>
              <a:t>4. TFA–4H</a:t>
            </a:r>
            <a:r>
              <a:rPr lang="en-US" baseline="-25000" dirty="0"/>
              <a:t>2</a:t>
            </a:r>
            <a:r>
              <a:rPr lang="en-US" dirty="0"/>
              <a:t>O (2)</a:t>
            </a:r>
          </a:p>
        </p:txBody>
      </p:sp>
      <p:pic>
        <p:nvPicPr>
          <p:cNvPr id="5" name="Picture 4" descr="Several red and white objects&#10;&#10;AI-generated content may be incorrect.">
            <a:extLst>
              <a:ext uri="{FF2B5EF4-FFF2-40B4-BE49-F238E27FC236}">
                <a16:creationId xmlns:a16="http://schemas.microsoft.com/office/drawing/2014/main" id="{D3FE7999-8478-5406-82EC-6CB442B159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33688" y="3593067"/>
            <a:ext cx="3258312" cy="21447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" name="Picture 6" descr="A close-up of several pills&#10;&#10;AI-generated content may be incorrect.">
            <a:extLst>
              <a:ext uri="{FF2B5EF4-FFF2-40B4-BE49-F238E27FC236}">
                <a16:creationId xmlns:a16="http://schemas.microsoft.com/office/drawing/2014/main" id="{D2867404-307E-3E23-68B2-E85A4DE9C5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33087" y="3593067"/>
            <a:ext cx="3200601" cy="21520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Picture 8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9550D8A3-7F75-F6C8-F579-34E873D5E8A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6544" y="3596706"/>
            <a:ext cx="2866544" cy="214478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E0FC5366-6513-06B6-998A-A30DD902C8D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593067"/>
            <a:ext cx="2866544" cy="21520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DFB49798-2762-8F36-15DD-A3783F55151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25456" y="675831"/>
            <a:ext cx="2866544" cy="16860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F0871117-B6B6-3CC9-15E2-973B6E5B426D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92379" y="675831"/>
            <a:ext cx="2533076" cy="16860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Picture 16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A77B5E5F-65AB-0030-791A-FFA1900A5095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50794" y="675831"/>
            <a:ext cx="2424910" cy="168601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9" name="Picture 18" descr="Several objects with different colors&#10;&#10;AI-generated content may be incorrect.">
            <a:extLst>
              <a:ext uri="{FF2B5EF4-FFF2-40B4-BE49-F238E27FC236}">
                <a16:creationId xmlns:a16="http://schemas.microsoft.com/office/drawing/2014/main" id="{D6C384C0-151F-A903-FA89-03FD47FEBBA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53388" y="679470"/>
            <a:ext cx="2080731" cy="168237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1" name="Picture 20" descr="A molecule of vitamin c&#10;&#10;AI-generated content may be incorrect.">
            <a:extLst>
              <a:ext uri="{FF2B5EF4-FFF2-40B4-BE49-F238E27FC236}">
                <a16:creationId xmlns:a16="http://schemas.microsoft.com/office/drawing/2014/main" id="{DE855B47-54BD-0DD3-A0F2-025F27E01D8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679470"/>
            <a:ext cx="2253388" cy="168601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B4BE2AD2-5C61-A1F2-43C3-1FECB00C4779}"/>
              </a:ext>
            </a:extLst>
          </p:cNvPr>
          <p:cNvSpPr txBox="1"/>
          <p:nvPr/>
        </p:nvSpPr>
        <p:spPr>
          <a:xfrm>
            <a:off x="217955" y="2361842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12 kcal/mol (8.29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63 kcal/mol (3.54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91 kcal/mol (2.54%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10F111E-6179-A524-2276-BFAE53ABC4FB}"/>
              </a:ext>
            </a:extLst>
          </p:cNvPr>
          <p:cNvSpPr txBox="1"/>
          <p:nvPr/>
        </p:nvSpPr>
        <p:spPr>
          <a:xfrm>
            <a:off x="2393352" y="2361841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70 kcal/mol (2.16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84 kcal/mol (2.4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94 kcal/mol (2.39%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CECE915-84CD-0BB6-7D47-A54DB04970DE}"/>
              </a:ext>
            </a:extLst>
          </p:cNvPr>
          <p:cNvSpPr txBox="1"/>
          <p:nvPr/>
        </p:nvSpPr>
        <p:spPr>
          <a:xfrm>
            <a:off x="4654510" y="2361840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32 kcal/mol (0.51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10 kcal/mol (1.50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04 kcal/mol (2.03%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D71A0C8-417F-EAA8-CDC5-1720AD0D61C2}"/>
              </a:ext>
            </a:extLst>
          </p:cNvPr>
          <p:cNvSpPr txBox="1"/>
          <p:nvPr/>
        </p:nvSpPr>
        <p:spPr>
          <a:xfrm>
            <a:off x="7238490" y="2377289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74 kcal/mol (1.95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95 kcal/mol (1.9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08 kcal/mol (1.90%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1490590-2F60-8AE9-83EE-391039371029}"/>
              </a:ext>
            </a:extLst>
          </p:cNvPr>
          <p:cNvSpPr txBox="1"/>
          <p:nvPr/>
        </p:nvSpPr>
        <p:spPr>
          <a:xfrm>
            <a:off x="9849989" y="2361839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37 kcal/mol (0.45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19 kcal/mol (1.27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15 kcal/mol (1.70%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DC9C3818-BF41-C6E1-DD86-EB93AD33DBB8}"/>
              </a:ext>
            </a:extLst>
          </p:cNvPr>
          <p:cNvSpPr txBox="1"/>
          <p:nvPr/>
        </p:nvSpPr>
        <p:spPr>
          <a:xfrm>
            <a:off x="573743" y="5705406"/>
            <a:ext cx="171905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35 kcal/mol (0.47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25 kcal/mol (1.14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24 kcal/mol (1.45%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D68240B-F26A-5667-78BC-C7D28F177B0B}"/>
              </a:ext>
            </a:extLst>
          </p:cNvPr>
          <p:cNvSpPr txBox="1"/>
          <p:nvPr/>
        </p:nvSpPr>
        <p:spPr>
          <a:xfrm>
            <a:off x="3439875" y="5705407"/>
            <a:ext cx="193300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48 kcal/mol (3.62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98 kcal/mol (1.8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25 kcal/mol (1.42%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3253C95-8C96-7CDF-4BCE-38CB370BE306}"/>
              </a:ext>
            </a:extLst>
          </p:cNvPr>
          <p:cNvSpPr txBox="1"/>
          <p:nvPr/>
        </p:nvSpPr>
        <p:spPr>
          <a:xfrm>
            <a:off x="6424648" y="570540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05 kcal/mol (0.96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21 kcal/mol (1.23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32 kcal/mol (1.26%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C3D72E3-2039-AA32-B319-BFAEB0DD1BD8}"/>
              </a:ext>
            </a:extLst>
          </p:cNvPr>
          <p:cNvSpPr txBox="1"/>
          <p:nvPr/>
        </p:nvSpPr>
        <p:spPr>
          <a:xfrm>
            <a:off x="9654105" y="5705405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64 kcal/mol (2.48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16 kcal/mol (1.35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43 kcal/mol (1.05%)</a:t>
            </a:r>
          </a:p>
        </p:txBody>
      </p:sp>
    </p:spTree>
    <p:extLst>
      <p:ext uri="{BB962C8B-B14F-4D97-AF65-F5344CB8AC3E}">
        <p14:creationId xmlns:p14="http://schemas.microsoft.com/office/powerpoint/2010/main" val="282035467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6BCA6C8F-1EF8-DD32-7D0F-79943589100D}"/>
              </a:ext>
            </a:extLst>
          </p:cNvPr>
          <p:cNvSpPr txBox="1"/>
          <p:nvPr/>
        </p:nvSpPr>
        <p:spPr>
          <a:xfrm>
            <a:off x="5339438" y="41469"/>
            <a:ext cx="1743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. TFA-5H</a:t>
            </a:r>
            <a:r>
              <a:rPr lang="en-US" baseline="-25000" dirty="0"/>
              <a:t>2</a:t>
            </a:r>
            <a:r>
              <a:rPr lang="en-US" dirty="0"/>
              <a:t>O (1)</a:t>
            </a:r>
          </a:p>
        </p:txBody>
      </p:sp>
      <p:pic>
        <p:nvPicPr>
          <p:cNvPr id="4" name="Picture 3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2A562B37-E499-B478-2971-126B2B22FBD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7722" y="503911"/>
            <a:ext cx="2567791" cy="176139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19ABBC98-D1BD-F3FA-9A45-74D7FD3599C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0069" y="503912"/>
            <a:ext cx="2261067" cy="17613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62EB2BE8-F101-7B79-F033-FFFD5B60551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11136" y="504188"/>
            <a:ext cx="2499696" cy="1778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Picture 9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0B1EAF80-C5C0-BBB1-466D-DD272705C1E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36771" y="481307"/>
            <a:ext cx="2499696" cy="18112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Picture 11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531D5D83-B5F3-A398-805B-0BC65E8D631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836467" y="482441"/>
            <a:ext cx="2339077" cy="18004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A41AFE86-243B-15AF-1379-E0E692F54EF4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630194"/>
            <a:ext cx="2339077" cy="187057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 descr="Several pills in different positions&#10;&#10;AI-generated content may be incorrect.">
            <a:extLst>
              <a:ext uri="{FF2B5EF4-FFF2-40B4-BE49-F238E27FC236}">
                <a16:creationId xmlns:a16="http://schemas.microsoft.com/office/drawing/2014/main" id="{76A03E5C-EF0F-3CF6-65EE-E8DDDC46BC1A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9076" y="3632462"/>
            <a:ext cx="2344015" cy="18683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Picture 17" descr="Several red and white objects&#10;&#10;AI-generated content may be incorrect.">
            <a:extLst>
              <a:ext uri="{FF2B5EF4-FFF2-40B4-BE49-F238E27FC236}">
                <a16:creationId xmlns:a16="http://schemas.microsoft.com/office/drawing/2014/main" id="{B39D640D-D038-234A-FCCF-53AE3285F3C5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5144" y="3630194"/>
            <a:ext cx="2397528" cy="18703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0" name="Picture 19" descr="Several capsules and a molecule&#10;&#10;AI-generated content may be incorrect.">
            <a:extLst>
              <a:ext uri="{FF2B5EF4-FFF2-40B4-BE49-F238E27FC236}">
                <a16:creationId xmlns:a16="http://schemas.microsoft.com/office/drawing/2014/main" id="{28D405AF-97C6-016E-F268-141B47A90DF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82672" y="3632461"/>
            <a:ext cx="2398977" cy="18680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Picture 21" descr="Several white and red pills&#10;&#10;AI-generated content may be incorrect.">
            <a:extLst>
              <a:ext uri="{FF2B5EF4-FFF2-40B4-BE49-F238E27FC236}">
                <a16:creationId xmlns:a16="http://schemas.microsoft.com/office/drawing/2014/main" id="{AF85CDDA-E2C0-AE2A-1D90-326556FB7C9A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481649" y="3632461"/>
            <a:ext cx="2710351" cy="186803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DB57442A-85C9-EC69-24E0-8885E54480CD}"/>
              </a:ext>
            </a:extLst>
          </p:cNvPr>
          <p:cNvSpPr txBox="1"/>
          <p:nvPr/>
        </p:nvSpPr>
        <p:spPr>
          <a:xfrm>
            <a:off x="217955" y="2361842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00 kcal/mol (17.71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00 kcal/mol (14.2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00 kcal/mol (12.91%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20A93E4-A461-E63A-C311-3D166E3DC353}"/>
              </a:ext>
            </a:extLst>
          </p:cNvPr>
          <p:cNvSpPr txBox="1"/>
          <p:nvPr/>
        </p:nvSpPr>
        <p:spPr>
          <a:xfrm>
            <a:off x="2593730" y="229254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38 kcal/mol (7.27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43 kcal/mol (6.40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45 kcal/mol (6.01%)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50B1E69-5B51-1121-6816-AD5C8ACDB55A}"/>
              </a:ext>
            </a:extLst>
          </p:cNvPr>
          <p:cNvSpPr txBox="1"/>
          <p:nvPr/>
        </p:nvSpPr>
        <p:spPr>
          <a:xfrm>
            <a:off x="5119365" y="2379725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45 kcal/mol (6.16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49 kcal/mol (5.8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50 kcal/mol (5.87%)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BB971ED-C0E1-4989-E1DD-8D014FA2B7CC}"/>
              </a:ext>
            </a:extLst>
          </p:cNvPr>
          <p:cNvSpPr txBox="1"/>
          <p:nvPr/>
        </p:nvSpPr>
        <p:spPr>
          <a:xfrm>
            <a:off x="7582715" y="243099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47 kcal/mol (6.01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64 kcal/mol (4.3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72 kcal/mol (3.83%)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71FBA42-83B0-5608-4728-69FF5D9FE028}"/>
              </a:ext>
            </a:extLst>
          </p:cNvPr>
          <p:cNvSpPr txBox="1"/>
          <p:nvPr/>
        </p:nvSpPr>
        <p:spPr>
          <a:xfrm>
            <a:off x="10156567" y="237972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57 kcal/mol (4.73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74 kcal/mol (3.67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81 kcal/mol (3.30%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7186888-7870-6EE0-5EE9-57EB6B0086EF}"/>
              </a:ext>
            </a:extLst>
          </p:cNvPr>
          <p:cNvSpPr txBox="1"/>
          <p:nvPr/>
        </p:nvSpPr>
        <p:spPr>
          <a:xfrm>
            <a:off x="260799" y="5543697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58 kcal/mol (4.57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76 kcal/mol (3.48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84 kcal/mol (3.11%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88E706E-CE5D-7D33-C477-46BA8DC88C18}"/>
              </a:ext>
            </a:extLst>
          </p:cNvPr>
          <p:cNvSpPr txBox="1"/>
          <p:nvPr/>
        </p:nvSpPr>
        <p:spPr>
          <a:xfrm>
            <a:off x="2602344" y="559730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72 kcal/mol (3.31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90 kcal/mol (2.7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0.98 kcal/mol (2.49%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2C767A2-5F34-50B3-94E8-9A6523C578D3}"/>
              </a:ext>
            </a:extLst>
          </p:cNvPr>
          <p:cNvSpPr txBox="1"/>
          <p:nvPr/>
        </p:nvSpPr>
        <p:spPr>
          <a:xfrm>
            <a:off x="4972907" y="5576551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88 kcal/mol (2.30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97 kcal/mol (2.3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02 kcal/mol (2.32%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3E9DE481-6DDB-5C3E-BBDD-68CAACAB3022}"/>
              </a:ext>
            </a:extLst>
          </p:cNvPr>
          <p:cNvSpPr txBox="1"/>
          <p:nvPr/>
        </p:nvSpPr>
        <p:spPr>
          <a:xfrm>
            <a:off x="7373421" y="559730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84 kcal/mol (2.50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01 kcal/mol (2.2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08 kcal/mol (2.08%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7D6B038-8F3B-8BEB-A488-26C323849AAD}"/>
              </a:ext>
            </a:extLst>
          </p:cNvPr>
          <p:cNvSpPr txBox="1"/>
          <p:nvPr/>
        </p:nvSpPr>
        <p:spPr>
          <a:xfrm>
            <a:off x="9928085" y="5577727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70 kcal/mol (3.49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0.96 kcal/mol (2.41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08 kcal/mol (2.07%)</a:t>
            </a:r>
          </a:p>
        </p:txBody>
      </p:sp>
    </p:spTree>
    <p:extLst>
      <p:ext uri="{BB962C8B-B14F-4D97-AF65-F5344CB8AC3E}">
        <p14:creationId xmlns:p14="http://schemas.microsoft.com/office/powerpoint/2010/main" val="10312657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4DC17D5-71F6-079B-BDE0-F7538A712DBA}"/>
              </a:ext>
            </a:extLst>
          </p:cNvPr>
          <p:cNvSpPr txBox="1"/>
          <p:nvPr/>
        </p:nvSpPr>
        <p:spPr>
          <a:xfrm>
            <a:off x="5376668" y="118872"/>
            <a:ext cx="17432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5. TFA-5H</a:t>
            </a:r>
            <a:r>
              <a:rPr lang="en-US" baseline="-25000" dirty="0"/>
              <a:t>2</a:t>
            </a:r>
            <a:r>
              <a:rPr lang="en-US" dirty="0"/>
              <a:t>O (2)</a:t>
            </a:r>
          </a:p>
        </p:txBody>
      </p:sp>
      <p:pic>
        <p:nvPicPr>
          <p:cNvPr id="24" name="Picture 23" descr="Several pills falling off of each other&#10;&#10;AI-generated content may be incorrect.">
            <a:extLst>
              <a:ext uri="{FF2B5EF4-FFF2-40B4-BE49-F238E27FC236}">
                <a16:creationId xmlns:a16="http://schemas.microsoft.com/office/drawing/2014/main" id="{B22292A0-74C9-C9EB-BCD1-693CD6E1E97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25876"/>
            <a:ext cx="1495817" cy="111918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Picture 25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33837602-C498-C076-940E-834AD420EED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5817" y="488204"/>
            <a:ext cx="1972442" cy="14758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8" name="Picture 27" descr="Several molecular structures of a substance&#10;&#10;AI-generated content may be incorrect.">
            <a:extLst>
              <a:ext uri="{FF2B5EF4-FFF2-40B4-BE49-F238E27FC236}">
                <a16:creationId xmlns:a16="http://schemas.microsoft.com/office/drawing/2014/main" id="{66A14BE2-44AC-ECDD-74EE-C324F6636593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68259" y="525876"/>
            <a:ext cx="1972442" cy="14758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Picture 29" descr="A close-up of several pills&#10;&#10;AI-generated content may be incorrect.">
            <a:extLst>
              <a:ext uri="{FF2B5EF4-FFF2-40B4-BE49-F238E27FC236}">
                <a16:creationId xmlns:a16="http://schemas.microsoft.com/office/drawing/2014/main" id="{D70BBFDA-ACF2-FA17-5E15-12FCCF9D596E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0701" y="488204"/>
            <a:ext cx="2375739" cy="17775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2" name="Picture 31" descr="Several pills floating in the air&#10;&#10;AI-generated content may be incorrect.">
            <a:extLst>
              <a:ext uri="{FF2B5EF4-FFF2-40B4-BE49-F238E27FC236}">
                <a16:creationId xmlns:a16="http://schemas.microsoft.com/office/drawing/2014/main" id="{EB713B0E-2515-DA96-19DE-64763EC79BA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16440" y="521018"/>
            <a:ext cx="1972442" cy="147580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Picture 33" descr="A close-up of several pills&#10;&#10;AI-generated content may be incorrect.">
            <a:extLst>
              <a:ext uri="{FF2B5EF4-FFF2-40B4-BE49-F238E27FC236}">
                <a16:creationId xmlns:a16="http://schemas.microsoft.com/office/drawing/2014/main" id="{6EF6726D-4048-D35D-6F63-38202E37A3F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88882" y="370141"/>
            <a:ext cx="2375741" cy="17775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6" name="Picture 35" descr="Several white and red objects&#10;&#10;AI-generated content may be incorrect.">
            <a:extLst>
              <a:ext uri="{FF2B5EF4-FFF2-40B4-BE49-F238E27FC236}">
                <a16:creationId xmlns:a16="http://schemas.microsoft.com/office/drawing/2014/main" id="{EBE71A30-79AE-BDDC-1E37-3375C6ABD802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4023587"/>
            <a:ext cx="1271016" cy="95098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Picture 37" descr="Several pills in different colors&#10;&#10;AI-generated content may be incorrect.">
            <a:extLst>
              <a:ext uri="{FF2B5EF4-FFF2-40B4-BE49-F238E27FC236}">
                <a16:creationId xmlns:a16="http://schemas.microsoft.com/office/drawing/2014/main" id="{8CD46885-8C90-BB0C-078B-5B01D1F2C3D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55419" y="3835307"/>
            <a:ext cx="1774295" cy="13275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0" name="Picture 39" descr="Several white and red pills&#10;&#10;AI-generated content may be incorrect.">
            <a:extLst>
              <a:ext uri="{FF2B5EF4-FFF2-40B4-BE49-F238E27FC236}">
                <a16:creationId xmlns:a16="http://schemas.microsoft.com/office/drawing/2014/main" id="{1925EA3A-E16D-7AD9-2333-85EDA7BD08E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97908" y="3835307"/>
            <a:ext cx="1774295" cy="132754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2" name="Picture 41" descr="Several objects with different colors&#10;&#10;AI-generated content may be incorrect.">
            <a:extLst>
              <a:ext uri="{FF2B5EF4-FFF2-40B4-BE49-F238E27FC236}">
                <a16:creationId xmlns:a16="http://schemas.microsoft.com/office/drawing/2014/main" id="{F67B6209-F4EE-030F-3774-3149F689D2FE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33274" y="4029170"/>
            <a:ext cx="1414854" cy="10586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4" name="Picture 43" descr="Several objects with different colors&#10;&#10;AI-generated content may be incorrect.">
            <a:extLst>
              <a:ext uri="{FF2B5EF4-FFF2-40B4-BE49-F238E27FC236}">
                <a16:creationId xmlns:a16="http://schemas.microsoft.com/office/drawing/2014/main" id="{62DA3144-F497-940E-7D74-FD611D8784AE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6000" y="4019468"/>
            <a:ext cx="1263292" cy="94521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6" name="Picture 45" descr="Several red and white objects&#10;&#10;AI-generated content may be incorrect.">
            <a:extLst>
              <a:ext uri="{FF2B5EF4-FFF2-40B4-BE49-F238E27FC236}">
                <a16:creationId xmlns:a16="http://schemas.microsoft.com/office/drawing/2014/main" id="{6B3A9E3D-E545-B714-4FA4-687CCC4C496A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59292" y="3972666"/>
            <a:ext cx="1503774" cy="112514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8" name="Picture 47" descr="Several red and white objects&#10;&#10;AI-generated content may be incorrect.">
            <a:extLst>
              <a:ext uri="{FF2B5EF4-FFF2-40B4-BE49-F238E27FC236}">
                <a16:creationId xmlns:a16="http://schemas.microsoft.com/office/drawing/2014/main" id="{262083F7-B941-F75F-BC1F-77A4AAA8C6E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825751" y="4019468"/>
            <a:ext cx="1414852" cy="105860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Picture 49" descr="Several red and white objects&#10;&#10;AI-generated content may be incorrect.">
            <a:extLst>
              <a:ext uri="{FF2B5EF4-FFF2-40B4-BE49-F238E27FC236}">
                <a16:creationId xmlns:a16="http://schemas.microsoft.com/office/drawing/2014/main" id="{900867AA-C389-57A3-4D38-324DE5E74449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383480" y="3864740"/>
            <a:ext cx="1634618" cy="12230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13D32B8-D468-15E3-B181-61B903996D77}"/>
              </a:ext>
            </a:extLst>
          </p:cNvPr>
          <p:cNvSpPr txBox="1"/>
          <p:nvPr/>
        </p:nvSpPr>
        <p:spPr>
          <a:xfrm>
            <a:off x="27377" y="1996822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78 kcal/mol (2.91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00 kcal/mol (2.2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</a:t>
            </a:r>
            <a:r>
              <a:rPr lang="en-US" sz="1200"/>
              <a:t>= 1.10 </a:t>
            </a:r>
            <a:r>
              <a:rPr lang="en-US" sz="1200" dirty="0"/>
              <a:t>kcal/mol (2.03%)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CA1BFC5-9672-F7DD-B44C-A0154C6B76AC}"/>
              </a:ext>
            </a:extLst>
          </p:cNvPr>
          <p:cNvSpPr txBox="1"/>
          <p:nvPr/>
        </p:nvSpPr>
        <p:spPr>
          <a:xfrm>
            <a:off x="1573299" y="214769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36 kcal/mol (0.74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26 kcal/mol (1.40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21 kcal/mol (1.68%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EB24CF5-1908-A2BC-41CF-8FA8732E5986}"/>
              </a:ext>
            </a:extLst>
          </p:cNvPr>
          <p:cNvSpPr txBox="1"/>
          <p:nvPr/>
        </p:nvSpPr>
        <p:spPr>
          <a:xfrm>
            <a:off x="5619090" y="2233019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18 kcal/mol (1.15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23 kcal/mol (1.4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25 kcal/mol (1.51%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6A3C145-D95B-B48C-28B0-B5C36B2411EC}"/>
              </a:ext>
            </a:extLst>
          </p:cNvPr>
          <p:cNvSpPr txBox="1"/>
          <p:nvPr/>
        </p:nvSpPr>
        <p:spPr>
          <a:xfrm>
            <a:off x="3646648" y="2147698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0.89 kcal/mol (2.23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13 kcal/mol (1.7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24 kcal/mol (1.58%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168CF73-0C61-7389-E8B3-6CEC77351AB9}"/>
              </a:ext>
            </a:extLst>
          </p:cNvPr>
          <p:cNvSpPr txBox="1"/>
          <p:nvPr/>
        </p:nvSpPr>
        <p:spPr>
          <a:xfrm>
            <a:off x="7715699" y="229857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21 kcal/mol (1.07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25 kcal/mol (1.41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27 kcal/mol (1.51%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543F886-4BF1-7A7F-B1D5-573F0C25E2CE}"/>
              </a:ext>
            </a:extLst>
          </p:cNvPr>
          <p:cNvSpPr txBox="1"/>
          <p:nvPr/>
        </p:nvSpPr>
        <p:spPr>
          <a:xfrm>
            <a:off x="10068013" y="2298574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26 kcal/mol (0.95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32 kcal/mol (1.2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34 kcal/mol (1.34%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114B8B-ED8D-DB06-F0E9-8F2F57008D6A}"/>
              </a:ext>
            </a:extLst>
          </p:cNvPr>
          <p:cNvSpPr txBox="1"/>
          <p:nvPr/>
        </p:nvSpPr>
        <p:spPr>
          <a:xfrm>
            <a:off x="0" y="5351135"/>
            <a:ext cx="16269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43 kcal/mol (0.64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38 kcal/mol (1.12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35 kcal/mol (1.32%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7A74EA7-68CA-A19B-ED3B-6F69A343A210}"/>
              </a:ext>
            </a:extLst>
          </p:cNvPr>
          <p:cNvSpPr txBox="1"/>
          <p:nvPr/>
        </p:nvSpPr>
        <p:spPr>
          <a:xfrm>
            <a:off x="1406675" y="5351135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47 kcal/mol (0.59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40 kcal/mol (1.07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37 kcal/mol (1.27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18D4346-16B9-C083-4834-E4D8A43F8664}"/>
              </a:ext>
            </a:extLst>
          </p:cNvPr>
          <p:cNvSpPr txBox="1"/>
          <p:nvPr/>
        </p:nvSpPr>
        <p:spPr>
          <a:xfrm>
            <a:off x="2954725" y="5375517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25 kcal/mol (0.98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35 kcal/mol (1.1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39 kcal/mol (1.23%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72250269-0DD0-8BC8-E5EF-D9E23B0A110D}"/>
              </a:ext>
            </a:extLst>
          </p:cNvPr>
          <p:cNvSpPr txBox="1"/>
          <p:nvPr/>
        </p:nvSpPr>
        <p:spPr>
          <a:xfrm>
            <a:off x="4542102" y="5348319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26 kcal/mol (0.94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36 kcal/mol (1.16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41 kcal/mol (1.20%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4590034-8CE1-0E8D-FF2D-83CD610FE04F}"/>
              </a:ext>
            </a:extLst>
          </p:cNvPr>
          <p:cNvSpPr txBox="1"/>
          <p:nvPr/>
        </p:nvSpPr>
        <p:spPr>
          <a:xfrm>
            <a:off x="5998962" y="5348319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51 kcal/mol (0.53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45 kcal/mol (0.99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42 kcal/mol (1.18%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128F971-7650-4C16-1B4C-4CF133F8E993}"/>
              </a:ext>
            </a:extLst>
          </p:cNvPr>
          <p:cNvSpPr txBox="1"/>
          <p:nvPr/>
        </p:nvSpPr>
        <p:spPr>
          <a:xfrm>
            <a:off x="7376848" y="5338616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16 kcal/mol (1.19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35 kcal/mol (1.18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43 kcal/mol (1.15%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AE03D84-86BC-8DFF-9B53-B0836C649DCD}"/>
              </a:ext>
            </a:extLst>
          </p:cNvPr>
          <p:cNvSpPr txBox="1"/>
          <p:nvPr/>
        </p:nvSpPr>
        <p:spPr>
          <a:xfrm>
            <a:off x="8787256" y="5365127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10 kcal/mol (1.37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35 kcal/mol (1.18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46 kcal/mol (1.10%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BE147C2-D903-46AC-EFD4-C5B221DD9BF0}"/>
              </a:ext>
            </a:extLst>
          </p:cNvPr>
          <p:cNvSpPr txBox="1"/>
          <p:nvPr/>
        </p:nvSpPr>
        <p:spPr>
          <a:xfrm>
            <a:off x="10292050" y="5338616"/>
            <a:ext cx="181747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1200" dirty="0"/>
              <a:t>Δ</a:t>
            </a:r>
            <a:r>
              <a:rPr lang="en-US" sz="1200" dirty="0"/>
              <a:t>G(216.65K) = 1.34 kcal/mol (0.78%)</a:t>
            </a:r>
          </a:p>
          <a:p>
            <a:r>
              <a:rPr lang="el-GR" sz="1200" dirty="0"/>
              <a:t>Δ</a:t>
            </a:r>
            <a:r>
              <a:rPr lang="en-US" sz="1200" dirty="0"/>
              <a:t>G(273.15K) = 1.44 kcal/mol (1.00%)</a:t>
            </a:r>
          </a:p>
          <a:p>
            <a:r>
              <a:rPr lang="el-GR" sz="1200" dirty="0"/>
              <a:t>Δ</a:t>
            </a:r>
            <a:r>
              <a:rPr lang="en-US" sz="1200" dirty="0"/>
              <a:t>G(298.15K) = 1.48 kcal/mol (1.06%)</a:t>
            </a:r>
          </a:p>
        </p:txBody>
      </p:sp>
    </p:spTree>
    <p:extLst>
      <p:ext uri="{BB962C8B-B14F-4D97-AF65-F5344CB8AC3E}">
        <p14:creationId xmlns:p14="http://schemas.microsoft.com/office/powerpoint/2010/main" val="303838995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F657D604-8619-D191-3170-205D54731114}"/>
              </a:ext>
            </a:extLst>
          </p:cNvPr>
          <p:cNvSpPr txBox="1"/>
          <p:nvPr/>
        </p:nvSpPr>
        <p:spPr>
          <a:xfrm>
            <a:off x="5376668" y="118872"/>
            <a:ext cx="14386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6. TFA-6H</a:t>
            </a:r>
            <a:r>
              <a:rPr lang="en-US" baseline="-25000" dirty="0"/>
              <a:t>2</a:t>
            </a:r>
            <a:r>
              <a:rPr lang="en-US" dirty="0"/>
              <a:t>O</a:t>
            </a:r>
          </a:p>
        </p:txBody>
      </p:sp>
      <p:pic>
        <p:nvPicPr>
          <p:cNvPr id="4" name="Picture 3" descr="Several capsules of a substance&#10;&#10;AI-generated content may be incorrect.">
            <a:extLst>
              <a:ext uri="{FF2B5EF4-FFF2-40B4-BE49-F238E27FC236}">
                <a16:creationId xmlns:a16="http://schemas.microsoft.com/office/drawing/2014/main" id="{AEF001B6-EFE3-C9EA-F714-F64020F1C03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58638"/>
            <a:ext cx="3904488" cy="3161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Picture 5" descr="Several different colored objects&#10;&#10;AI-generated content may be incorrect.">
            <a:extLst>
              <a:ext uri="{FF2B5EF4-FFF2-40B4-BE49-F238E27FC236}">
                <a16:creationId xmlns:a16="http://schemas.microsoft.com/office/drawing/2014/main" id="{1C1B2D85-1C5E-07E1-4919-B006E56C79A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04488" y="1258636"/>
            <a:ext cx="4220708" cy="3161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Picture 7" descr="Several objects with different colors&#10;&#10;AI-generated content may be incorrect.">
            <a:extLst>
              <a:ext uri="{FF2B5EF4-FFF2-40B4-BE49-F238E27FC236}">
                <a16:creationId xmlns:a16="http://schemas.microsoft.com/office/drawing/2014/main" id="{6018988F-4092-A189-D1C6-D82224436B0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5196" y="1258636"/>
            <a:ext cx="4037668" cy="31619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EAAF5911-2EFA-AAB4-F6A3-48C2E3DBEE4B}"/>
              </a:ext>
            </a:extLst>
          </p:cNvPr>
          <p:cNvSpPr txBox="1"/>
          <p:nvPr/>
        </p:nvSpPr>
        <p:spPr>
          <a:xfrm>
            <a:off x="181198" y="4907277"/>
            <a:ext cx="3620415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0 kcal/mol (8.56%)</a:t>
            </a:r>
          </a:p>
          <a:p>
            <a:r>
              <a:rPr lang="el-GR" dirty="0"/>
              <a:t>Δ</a:t>
            </a:r>
            <a:r>
              <a:rPr lang="en-US" dirty="0"/>
              <a:t>G(273.15K) = 0 kcal/mol (8.59%)</a:t>
            </a:r>
          </a:p>
          <a:p>
            <a:r>
              <a:rPr lang="el-GR" dirty="0"/>
              <a:t>Δ</a:t>
            </a:r>
            <a:r>
              <a:rPr lang="en-US" dirty="0"/>
              <a:t>G(298.15K) = 0 kcal/mol (8.45%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C177516-C2A8-367C-1AE9-B37893C8BE74}"/>
              </a:ext>
            </a:extLst>
          </p:cNvPr>
          <p:cNvSpPr txBox="1"/>
          <p:nvPr/>
        </p:nvSpPr>
        <p:spPr>
          <a:xfrm>
            <a:off x="4113263" y="4907277"/>
            <a:ext cx="380956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.40 kcal/mol (3.37%)</a:t>
            </a:r>
          </a:p>
          <a:p>
            <a:r>
              <a:rPr lang="el-GR" dirty="0"/>
              <a:t>Δ</a:t>
            </a:r>
            <a:r>
              <a:rPr lang="en-US" dirty="0"/>
              <a:t>G(273.15K) = .39 kcal/mol (4.18%)</a:t>
            </a:r>
          </a:p>
          <a:p>
            <a:r>
              <a:rPr lang="el-GR" dirty="0"/>
              <a:t>Δ</a:t>
            </a:r>
            <a:r>
              <a:rPr lang="en-US" dirty="0"/>
              <a:t>G(298.15K) = .39 kcal/mol (4.41%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38DC21A-AA59-8B6B-1F75-7304C5BE4AB6}"/>
              </a:ext>
            </a:extLst>
          </p:cNvPr>
          <p:cNvSpPr txBox="1"/>
          <p:nvPr/>
        </p:nvSpPr>
        <p:spPr>
          <a:xfrm>
            <a:off x="8242451" y="4907277"/>
            <a:ext cx="3809569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dirty="0"/>
              <a:t>Δ</a:t>
            </a:r>
            <a:r>
              <a:rPr lang="en-US" dirty="0"/>
              <a:t>G(216.65K) = .40 kcal/mol (3.40%)</a:t>
            </a:r>
          </a:p>
          <a:p>
            <a:r>
              <a:rPr lang="el-GR" dirty="0"/>
              <a:t>Δ</a:t>
            </a:r>
            <a:r>
              <a:rPr lang="en-US" dirty="0"/>
              <a:t>G(273.15K) = .48 kcal/mol (3.56%)</a:t>
            </a:r>
          </a:p>
          <a:p>
            <a:r>
              <a:rPr lang="el-GR" dirty="0"/>
              <a:t>Δ</a:t>
            </a:r>
            <a:r>
              <a:rPr lang="en-US" dirty="0"/>
              <a:t>G(298.15K) = .51 kcal/mol (3.54%)</a:t>
            </a:r>
          </a:p>
        </p:txBody>
      </p:sp>
    </p:spTree>
    <p:extLst>
      <p:ext uri="{BB962C8B-B14F-4D97-AF65-F5344CB8AC3E}">
        <p14:creationId xmlns:p14="http://schemas.microsoft.com/office/powerpoint/2010/main" val="2254738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08</TotalTime>
  <Words>2730</Words>
  <Application>Microsoft Macintosh PowerPoint</Application>
  <PresentationFormat>Widescreen</PresentationFormat>
  <Paragraphs>216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6" baseType="lpstr">
      <vt:lpstr>Aptos</vt:lpstr>
      <vt:lpstr>Aptos Display</vt:lpstr>
      <vt:lpstr>Arial</vt:lpstr>
      <vt:lpstr>Symbo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Walker Smith0-Student</dc:creator>
  <cp:lastModifiedBy>Caroline Glick</cp:lastModifiedBy>
  <cp:revision>28</cp:revision>
  <dcterms:created xsi:type="dcterms:W3CDTF">2025-09-22T18:55:58Z</dcterms:created>
  <dcterms:modified xsi:type="dcterms:W3CDTF">2025-12-01T19:40:12Z</dcterms:modified>
</cp:coreProperties>
</file>